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853" y="-34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624E55-F19B-4420-A1B1-3761C2AFBAB4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FD6021-23E7-4836-8662-7ECA02AC94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4403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FD6021-23E7-4836-8662-7ECA02AC94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387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51070-C376-4FF0-AE6D-0F55787680BC}" type="datetimeFigureOut">
              <a:rPr lang="en-US" smtClean="0"/>
              <a:pPr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8200" y="30480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(A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953000" y="30480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(B)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1F91712E-352B-40BA-951F-DFE7B40A6B2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4783" y="770034"/>
            <a:ext cx="2741017" cy="323439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474393E8-8EF0-4E69-9E9B-D063C1C6B1C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762000"/>
            <a:ext cx="2805643" cy="3242424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E999DF32-9953-499B-85EC-B6FCD49F9767}"/>
              </a:ext>
            </a:extLst>
          </p:cNvPr>
          <p:cNvSpPr txBox="1"/>
          <p:nvPr/>
        </p:nvSpPr>
        <p:spPr>
          <a:xfrm>
            <a:off x="5570570" y="3986838"/>
            <a:ext cx="2735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            -1            0            1            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80138AFF-0313-4A36-AD4B-81DCA707124E}"/>
              </a:ext>
            </a:extLst>
          </p:cNvPr>
          <p:cNvSpPr txBox="1"/>
          <p:nvPr/>
        </p:nvSpPr>
        <p:spPr>
          <a:xfrm>
            <a:off x="1811956" y="3970840"/>
            <a:ext cx="2441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   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     2            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4">
            <a:extLst>
              <a:ext uri="{FF2B5EF4-FFF2-40B4-BE49-F238E27FC236}">
                <a16:creationId xmlns:a16="http://schemas.microsoft.com/office/drawing/2014/main" xmlns="" id="{1AE8C03C-31C1-47CD-AB5F-6F46F46F5040}"/>
              </a:ext>
            </a:extLst>
          </p:cNvPr>
          <p:cNvSpPr txBox="1"/>
          <p:nvPr/>
        </p:nvSpPr>
        <p:spPr>
          <a:xfrm rot="16200000">
            <a:off x="257091" y="1983584"/>
            <a:ext cx="1547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altLang="zh-CN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4">
            <a:extLst>
              <a:ext uri="{FF2B5EF4-FFF2-40B4-BE49-F238E27FC236}">
                <a16:creationId xmlns:a16="http://schemas.microsoft.com/office/drawing/2014/main" xmlns="" id="{6B62CA5E-27FF-4CB5-B16C-3B372C67B195}"/>
              </a:ext>
            </a:extLst>
          </p:cNvPr>
          <p:cNvSpPr txBox="1"/>
          <p:nvPr/>
        </p:nvSpPr>
        <p:spPr>
          <a:xfrm rot="16200000">
            <a:off x="4367323" y="1996096"/>
            <a:ext cx="1612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altLang="zh-CN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94076942-FDBC-4CBC-A06D-04A886A89DC8}"/>
              </a:ext>
            </a:extLst>
          </p:cNvPr>
          <p:cNvSpPr txBox="1"/>
          <p:nvPr/>
        </p:nvSpPr>
        <p:spPr>
          <a:xfrm>
            <a:off x="1828800" y="365860"/>
            <a:ext cx="182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48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_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0_CK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xmlns="" id="{DD87579D-A953-43FA-B81C-C17BCEEC891C}"/>
              </a:ext>
            </a:extLst>
          </p:cNvPr>
          <p:cNvSpPr/>
          <p:nvPr/>
        </p:nvSpPr>
        <p:spPr>
          <a:xfrm>
            <a:off x="6172200" y="365859"/>
            <a:ext cx="140936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48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_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0_CK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13">
            <a:extLst>
              <a:ext uri="{FF2B5EF4-FFF2-40B4-BE49-F238E27FC236}">
                <a16:creationId xmlns:a16="http://schemas.microsoft.com/office/drawing/2014/main" xmlns="" id="{C15BEE42-5467-454F-9B75-47841A2C3E7A}"/>
              </a:ext>
            </a:extLst>
          </p:cNvPr>
          <p:cNvSpPr txBox="1"/>
          <p:nvPr/>
        </p:nvSpPr>
        <p:spPr>
          <a:xfrm>
            <a:off x="1973610" y="4257817"/>
            <a:ext cx="15391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altLang="zh-CN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old change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13">
            <a:extLst>
              <a:ext uri="{FF2B5EF4-FFF2-40B4-BE49-F238E27FC236}">
                <a16:creationId xmlns:a16="http://schemas.microsoft.com/office/drawing/2014/main" xmlns="" id="{698E225E-838F-4D52-BCCE-07E45A8E3C22}"/>
              </a:ext>
            </a:extLst>
          </p:cNvPr>
          <p:cNvSpPr txBox="1"/>
          <p:nvPr/>
        </p:nvSpPr>
        <p:spPr>
          <a:xfrm>
            <a:off x="6261798" y="4271287"/>
            <a:ext cx="1474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altLang="zh-CN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old change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48A9CE59-7DB3-43CD-A6D8-2D9AFC17D256}"/>
              </a:ext>
            </a:extLst>
          </p:cNvPr>
          <p:cNvSpPr txBox="1"/>
          <p:nvPr/>
        </p:nvSpPr>
        <p:spPr>
          <a:xfrm>
            <a:off x="1175191" y="817487"/>
            <a:ext cx="307778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28">
            <a:extLst>
              <a:ext uri="{FF2B5EF4-FFF2-40B4-BE49-F238E27FC236}">
                <a16:creationId xmlns:a16="http://schemas.microsoft.com/office/drawing/2014/main" xmlns="" id="{48A9CE59-7DB3-43CD-A6D8-2D9AFC17D256}"/>
              </a:ext>
            </a:extLst>
          </p:cNvPr>
          <p:cNvSpPr txBox="1"/>
          <p:nvPr/>
        </p:nvSpPr>
        <p:spPr>
          <a:xfrm>
            <a:off x="5274129" y="1431469"/>
            <a:ext cx="307778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0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0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4169273" y="4207556"/>
            <a:ext cx="1317127" cy="593044"/>
            <a:chOff x="4253443" y="4291361"/>
            <a:chExt cx="1317127" cy="593044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xmlns="" id="{81B39F19-DC7D-46E4-8FFB-25A98B42A556}"/>
                </a:ext>
              </a:extLst>
            </p:cNvPr>
            <p:cNvSpPr txBox="1"/>
            <p:nvPr/>
          </p:nvSpPr>
          <p:spPr>
            <a:xfrm>
              <a:off x="4253443" y="4638184"/>
              <a:ext cx="13171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Up     None    Down</a:t>
              </a: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4779481" y="3968585"/>
              <a:ext cx="327259" cy="9728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2" name="矩形 1"/>
          <p:cNvSpPr/>
          <p:nvPr/>
        </p:nvSpPr>
        <p:spPr>
          <a:xfrm>
            <a:off x="740064" y="4953000"/>
            <a:ext cx="802293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S3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Volcano plot of all differentially expressed proteins (DEPs) identified in two sugarcane cultivars inoculated with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anthomonas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albilinean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LCP85-384 resistant and ROC20 susceptible to leaf scald). R48_Xa vs. R0_CK = Cultivar LCP85-384 inoculated with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X.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albilinean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48 h post inoculation,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hp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 vs. LCP85-384 inoculated with sterile medium (0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hp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. S48_Xa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0_CK = Cultivar ROC20 inoculated with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X.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albilinean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48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hp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 vs. ROC20 inoculated with sterile medium (0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hp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. DEPs showing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old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hanges </a:t>
            </a:r>
            <a:r>
              <a:rPr lang="en-US" altLang="zh-CN" sz="1200" dirty="0" smtClean="0">
                <a:latin typeface="Times New Roman"/>
                <a:cs typeface="Times New Roman"/>
              </a:rPr>
              <a:t>≥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1.5 (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upregulated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DEPs in red) or </a:t>
            </a:r>
            <a:r>
              <a:rPr lang="en-US" altLang="zh-CN" sz="1200" dirty="0" smtClean="0">
                <a:latin typeface="Times New Roman"/>
                <a:cs typeface="Times New Roman"/>
              </a:rPr>
              <a:t>≤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0.76 (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downregulated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DEPs in green) with p-value &lt; 0.05. Proteins with not significant changes are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labelled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in black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7880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175</Words>
  <Application>Microsoft Office PowerPoint</Application>
  <PresentationFormat>全屏显示(4:3)</PresentationFormat>
  <Paragraphs>44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P R 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tambo</dc:creator>
  <cp:lastModifiedBy>GSJ</cp:lastModifiedBy>
  <cp:revision>25</cp:revision>
  <dcterms:created xsi:type="dcterms:W3CDTF">2019-06-20T06:22:17Z</dcterms:created>
  <dcterms:modified xsi:type="dcterms:W3CDTF">2019-12-14T07:11:48Z</dcterms:modified>
</cp:coreProperties>
</file>